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156A0C-920A-41CB-A4A3-B87C13272AE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55DB62-F79B-4194-AB73-E292CCA850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E49992-2BE1-49EB-855D-E4BE1462362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4295CE-E5AB-4558-8BF2-57ACAA6ACEF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578C2F-FD24-4356-9DE8-94828D57223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039CB9-8743-4151-B043-9FC73C149E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013D11-5F4A-4485-AFBB-5C76912F55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300124-31C5-4E23-9E9D-B5BB64C818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F56406-912D-4190-B63C-D508917CBC4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548B9F-D75B-444B-A8AA-261ECE0650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DE7EB8-9B14-43E4-AFF4-10FFEA2859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FC5739-30E7-4255-9D69-8E6BC0517A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4B12DAC-322C-4389-B6B8-5CA7E23AC1D4}" type="datetime">
              <a:rPr b="0" lang="en-GB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B74B18D-1979-4992-90A8-83D8E39824E0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2"/>
          <p:cNvSpPr/>
          <p:nvPr/>
        </p:nvSpPr>
        <p:spPr>
          <a:xfrm>
            <a:off x="304920" y="338040"/>
            <a:ext cx="8518320" cy="5754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8160" rIns="38160" tIns="38160" bIns="38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Exon 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  <a:ea typeface="Courier New"/>
              </a:rPr>
              <a:t>TGCAAGTGTGGCCAAGAAGA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CATGATGTCCTCTTGAGCAATGAAGAGGATCGAAAAGTGGGAAAACTTTTTGAAGACACCAAGTATACCACTCTGATTGC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  <a:ea typeface="Courier New"/>
              </a:rPr>
              <a:t>TGCAAGTGTGGCCAAGAAGA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CATGATGTCCTCTTGAGCAATGAAGAGGATCGAAAAGTGGGAAAACTTTTTGAAGACACCAAGTATACCACTCTGATTGC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ysLysCysGlyGlnGluGluHisAspValLeuLeuSerAsnGluGluAspArgLysValGlyLysLysPheGluAspThrLysTyrThrThrLeuIleAl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AAACTAAAGTCAGATGGAATTCCCATGTATAAACGCAATGTTATGATATTGACGAATCCAGTTGCTGCCAAGAAGAATGTCTCCATCAATACAGTTACC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AAACTAAAGTCAGATGGAATTCCCATGTATAAACGCAATGTTATGATATTGACGAATCCAGTTGCTGCCAAGAAGAATGTCTCCATCAATACAGTTACC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LysLeuLysSerAspGlyIleProMetTyrLysArgAsnValMetIleLeuThrAsnProVallAlaAlaLysLysAsnValSerIleAsnThrValThr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Exon 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TGAGTGGGCTCCTCCTGTCCAGAATCAAGCATTGG-CCAGGCAGTACATGCAGATGCTACCCAAGGAAAAGCAGCCAGTAGCAGGCTCAGAGGGGGCAC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TGAGTGGGCTCCTCCTGTCCAGAATCAAGCATTGG-CCAGGCAGTACATGCAGATGCTACCCAAGGAAAAGCAGCCAGTAGCAGGCTCAGAGGGGGCAC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yrGluTrpAlaProProValGlnAsnGlnAlaLeuA-laArgGlnTyrMetGlnMetLeuProLysGluLysGlnProValAlaGlySerGluGlyAlaG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GTACCGGAAGAAGCAGCTGGCAAAGCAGCTCCCTGCACATGACCAGGACCCTTCAAAGTGCCATGAGTTGTCTCCCAGAGAGGTGAAGGAGATGGAGCAG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GTACCGGAAGAAGCAGCTGGCAAAGCAGCTCCCTGCACATGACCAGGACCCTTCAAAGTGCCATGAGTTGTCTCCCAGAGAGGTGAAGGAGATGGAGCAG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nTyrArgLysLysGlnLeuAlaLysGlnLeuProAlaHisGluGlnAspProSerLysCysHisGluLeuSerProArgGluValLysGluMetGluGlnP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TTGTGAAGAAATATAAGAGCGAAGCTCTGGGAGTAGGAGATGTCAAACTTCCCTGTGAGATGGATGCCCAAGGCCCCAAACAAATGAACATTCCTGGAGG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TTGTGAAGAAATATAAGAGCGAAGCTCTGGGAGTAGGAGATGTCAAACTTCCCTGTGAGATGGATGCCCAAGGCCCCAAACAAATGAACATTCCTGGAGG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heValLysLysTyrLysSerGluAlaLeuGlyValGlyAspValLysLeuProCysGluMetAspAlaGlnGlyProLysGlnMetAsnIleProGlyGl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Exon 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GATAGAAGCACCCCAGCAGCAGTGGGGGCCATGGAGGACAAATCTGCTGAGCACAAAAGAACTCAATAT-TCCTGCTATTGCTGCAAACTGAGTATGAAA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GATAGAAGCACCCCAGCAGCAGTGGGGGCCATGGAGGACAAATCTGCTGAGCACAAAAGAACTCAATAT-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spArgSerThrProAlaAlaValGlyAlaMetGluAspLysSerAlaGluHisLysArgThrGlnTy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AGGTGACCCAGCCATCTATGCCGAAAGGGCTGGCTATGATAAACTGTGGCACCCAGCTTGTTTTGTCTGCAGCACCTGCCATGAACTCCTGGTTGACAT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                                                                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CACCTGCCATGAACTCCTGGTTGACAT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HisLeuPro*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Exon 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TTTATTTTTGGAAGAATGAGAAGCTATACTGTGGCAGACATTACTGTGACAGCGAGAAACCCCGATGTGCTGGCTGTGACGAG-CTGATATTCAGCAAT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TTTATTTTTGGAAGAATGAGAAGCTATACTGTGGCAGACATTACTGTGACAGCGAGAAACCCCGATGTGCTGGCTGTGACGAG-CTGATATTCAGCAAT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 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GTATACCCAGGCAGAAAACCAGAATTGGCACCTGAAACACTTCTGCTGCTTTGACTGTGATAGCATTCTAGCTGGGGAGATATACGTGATGGTCAATGAC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GTATACCCAGGCAGAAAACCAGAATTGGCACCTGAAACACTTCTGCTGCTTTGACTGTGATAGCATTCTAGCTGGGGAGATATACGTGATGGTCAATGAC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 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AGCCCGTGTGCAAG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  <a:ea typeface="Courier New"/>
              </a:rPr>
              <a:t>CCTGCTATGTGAAGAATCACGCT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ourier New"/>
              </a:rPr>
              <a:t>wild-typ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AGCCCGTGTGCAAG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  <a:ea typeface="Courier New"/>
              </a:rPr>
              <a:t>CCTGCTATGTGAAGAATCACGCT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ourier New"/>
              </a:rPr>
              <a:t>splice varian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6-17T02:32:51Z</dcterms:created>
  <dc:creator>Rob Weeks</dc:creator>
  <dc:description/>
  <dc:language>en-US</dc:language>
  <cp:lastModifiedBy>Rob Weeks</cp:lastModifiedBy>
  <dcterms:modified xsi:type="dcterms:W3CDTF">2010-06-17T02:37:47Z</dcterms:modified>
  <cp:revision>1</cp:revision>
  <dc:subject/>
  <dc:title>Slide 1</dc:title>
</cp:coreProperties>
</file>